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403" r:id="rId2"/>
    <p:sldId id="40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4807" autoAdjust="0"/>
  </p:normalViewPr>
  <p:slideViewPr>
    <p:cSldViewPr snapToGrid="0">
      <p:cViewPr varScale="1">
        <p:scale>
          <a:sx n="73" d="100"/>
          <a:sy n="73" d="100"/>
        </p:scale>
        <p:origin x="1027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94C06C-3A8D-45BB-8CF2-48E71B15B85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396768-0552-4B27-BDF5-2074D602FA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6504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407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63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6576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850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5077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033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6206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5741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1232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804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724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C0FF6-F213-4294-AAC0-7C9560F40FC4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67EFA-D7F8-4AE7-8746-7CD18FFF40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4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580E6A-3290-0E45-A8F0-253AA5B58A7B}"/>
              </a:ext>
            </a:extLst>
          </p:cNvPr>
          <p:cNvSpPr txBox="1"/>
          <p:nvPr/>
        </p:nvSpPr>
        <p:spPr>
          <a:xfrm>
            <a:off x="241300" y="5123102"/>
            <a:ext cx="11709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Pathological images of the uterine tumor. (A) Estrogen receptor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ositive (B)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rogesteron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receptor positive (C) p53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null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5BED72C-8AE6-0D5D-23A4-E3EF8601BD9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483" y="1207008"/>
            <a:ext cx="3487466" cy="264566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B575C10-9E36-489E-C7E3-EEFA6C39CEB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8053" y="1207008"/>
            <a:ext cx="3588187" cy="272207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6D40867-4094-1402-BE21-0A54F5151E93}"/>
              </a:ext>
            </a:extLst>
          </p:cNvPr>
          <p:cNvSpPr txBox="1"/>
          <p:nvPr/>
        </p:nvSpPr>
        <p:spPr>
          <a:xfrm>
            <a:off x="466483" y="3929081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FFDE880-B0B4-5795-7489-C3E9E089C050}"/>
              </a:ext>
            </a:extLst>
          </p:cNvPr>
          <p:cNvSpPr txBox="1"/>
          <p:nvPr/>
        </p:nvSpPr>
        <p:spPr>
          <a:xfrm>
            <a:off x="4421771" y="3963285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923EAC0-C192-6BB8-B742-4C7DB7032C3F}"/>
              </a:ext>
            </a:extLst>
          </p:cNvPr>
          <p:cNvSpPr txBox="1"/>
          <p:nvPr/>
        </p:nvSpPr>
        <p:spPr>
          <a:xfrm>
            <a:off x="8476627" y="3978370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DE1588DB-93FE-FD91-8F93-71C8A39FCF8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1771" y="1252744"/>
            <a:ext cx="3467609" cy="263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462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E580E6A-3290-0E45-A8F0-253AA5B58A7B}"/>
              </a:ext>
            </a:extLst>
          </p:cNvPr>
          <p:cNvSpPr txBox="1"/>
          <p:nvPr/>
        </p:nvSpPr>
        <p:spPr>
          <a:xfrm>
            <a:off x="482600" y="5988734"/>
            <a:ext cx="117094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Pathological images of the breast cancer. (A) Hematoxylin and eosin staining showing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vasive ductal carcinoma,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cirrhous type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(B) ER : 3+ (100%), (C)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PgR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: 2+ (3%); (D)Her2 : 2+, (E) E-cadherin : positive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4826D2FA-6C00-2915-0BF4-32AC4D94F7D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6144" y="3065913"/>
            <a:ext cx="3121152" cy="234086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B7E6F4FC-33C6-A010-A82A-3BFE72B3D1A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752" y="222935"/>
            <a:ext cx="3121152" cy="2340864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0852F67-1BCC-1575-B274-21B4A0189C79}"/>
              </a:ext>
            </a:extLst>
          </p:cNvPr>
          <p:cNvSpPr txBox="1"/>
          <p:nvPr/>
        </p:nvSpPr>
        <p:spPr>
          <a:xfrm>
            <a:off x="580136" y="2598003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4A70227E-56DF-E047-A3BE-A2FE20FACA4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5424" y="257139"/>
            <a:ext cx="3121152" cy="2340864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2ADE7319-6BD5-41C3-2FA1-08B156731EF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7552" y="257139"/>
            <a:ext cx="3121152" cy="2340864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102AA00-4E7D-839B-8C74-45F945A30943}"/>
              </a:ext>
            </a:extLst>
          </p:cNvPr>
          <p:cNvSpPr txBox="1"/>
          <p:nvPr/>
        </p:nvSpPr>
        <p:spPr>
          <a:xfrm>
            <a:off x="4535424" y="2632207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0BE09BE-6919-0F79-2B99-190872924042}"/>
              </a:ext>
            </a:extLst>
          </p:cNvPr>
          <p:cNvSpPr txBox="1"/>
          <p:nvPr/>
        </p:nvSpPr>
        <p:spPr>
          <a:xfrm>
            <a:off x="8590280" y="2647292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dirty="0"/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F479A65E-B90A-2185-0C62-5E7C11C3DB9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6064" y="3123770"/>
            <a:ext cx="3121152" cy="2340864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D4CCCD8-7FE9-5CA0-0436-AAA2860BBB7C}"/>
              </a:ext>
            </a:extLst>
          </p:cNvPr>
          <p:cNvSpPr txBox="1"/>
          <p:nvPr/>
        </p:nvSpPr>
        <p:spPr>
          <a:xfrm>
            <a:off x="1962912" y="5464634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40E4FC8-D0A6-B8C8-4A3A-D3075A309A5F}"/>
              </a:ext>
            </a:extLst>
          </p:cNvPr>
          <p:cNvSpPr txBox="1"/>
          <p:nvPr/>
        </p:nvSpPr>
        <p:spPr>
          <a:xfrm>
            <a:off x="6337300" y="5434736"/>
            <a:ext cx="6217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81431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110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ctis</dc:creator>
  <cp:lastModifiedBy>Manuela Florina Marcus</cp:lastModifiedBy>
  <cp:revision>28</cp:revision>
  <dcterms:created xsi:type="dcterms:W3CDTF">2020-07-01T06:14:37Z</dcterms:created>
  <dcterms:modified xsi:type="dcterms:W3CDTF">2023-03-24T14:18:23Z</dcterms:modified>
</cp:coreProperties>
</file>